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80" r:id="rId2"/>
    <p:sldId id="257" r:id="rId3"/>
    <p:sldId id="258" r:id="rId4"/>
    <p:sldId id="260" r:id="rId5"/>
    <p:sldId id="261" r:id="rId6"/>
    <p:sldId id="259" r:id="rId7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643"/>
  </p:normalViewPr>
  <p:slideViewPr>
    <p:cSldViewPr snapToGrid="0" snapToObjects="1">
      <p:cViewPr varScale="1">
        <p:scale>
          <a:sx n="116" d="100"/>
          <a:sy n="116" d="100"/>
        </p:scale>
        <p:origin x="216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C951EB-F89F-0D46-8837-05455F066F10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3D84D1-7B2D-EB47-A113-503C8187BAF7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332623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BF8C75-DFD9-40AF-9310-02BA4CCB5629}" type="slidenum">
              <a:rPr lang="zh-TW" altLang="en-US">
                <a:solidFill>
                  <a:prstClr val="black"/>
                </a:solidFill>
              </a:rPr>
              <a:pPr/>
              <a:t>1</a:t>
            </a:fld>
            <a:endParaRPr lang="zh-TW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82153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DB05893-AE17-1A4B-978E-F7E43ED200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F6AD34BA-386E-0F42-89E4-C0D034F7A2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801CDE9-12DB-B94B-A38C-C021290E9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FC7E477-6B79-4A40-B76D-7029F55C5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B551646-3945-B441-A851-937D50074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60903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D3739A3-FA8A-1640-8677-F921E848E3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967D300-C0D3-204B-949D-38BE6F3E28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4A35975-B6BC-E147-BCB9-3F8B8D6E6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5D2600A-4DCF-394B-8BFD-3D891B97E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2BA3B9D-898B-D245-BCB2-90A14DD15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784312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06EC8720-849D-F44B-BE04-B0F0137B46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6F07CE7A-79CA-EA4F-B4D4-E8B33F20C9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C17D515-C049-844A-8344-338E4715C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6E5E311-C545-3043-B924-3054EE9EA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1426148-225D-D04A-83B7-E9E4C2DD1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947766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8E28F3B-CFD9-3946-B2D4-03BAAC8D99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96CAFC6-AB25-AE4B-B20E-D0F0D2EC34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5A40FBB-B412-C64B-BD1D-74F5EB035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81EED37-D5ED-A045-B967-8FA0474A0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C085637-D454-0E4D-80D9-391961DBB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34997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3318B5D-DF6C-224E-8B3D-117B723DD6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954C5001-51E8-1445-90A4-7438AADBDA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AE85A0D3-1124-7E49-A362-291321187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78A8904-090B-D24C-A18F-EA1CECCF1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8F79075-378C-3447-A2A4-B6C294BAB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017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49A03D8-49B0-484B-B61B-A92200D437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473507C-D92B-4640-B5A7-120729E6B8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1A847316-3136-DA4E-9D78-781AAFFE71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BC795AB6-1032-FE47-B7FC-2E7B60449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7134804-4EF2-9442-A120-A99B68B91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E2481FFE-8D23-FC4A-956E-55502370C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42518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06D4A19-CCDC-494F-98C0-7A0419C190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3662D85-B0ED-F04C-B139-5796F5564E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5B93F750-4CB3-A945-B972-9D160C179A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88D681CB-0099-0B41-8B80-0AF0657DF3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B5729074-093F-B54C-AC40-1977B29057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4A735F01-A892-B64D-83D3-D82039A80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B1EDFF54-9FC6-F84D-8570-4898D7FAB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8DA44978-F208-B84D-9721-BEADF6234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011269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37B456A-3F7B-3E4F-974B-17C11C9041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F0B0964E-472F-8043-B715-E33922D7F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5272E13F-D269-434F-A50C-103FD9337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41CE2E26-0B67-2E43-9F31-FB1CBA9CF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931598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8413212B-F592-7F4A-8F0B-E905EEB4E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D1156106-9244-884E-A730-FE01A5A95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AF3E4449-208F-FE4F-864A-FD5F14006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71023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3D28AAD-8CC3-7348-9342-843372B24C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A08D893C-E5E4-0648-96BA-9F34BC9756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1D927222-9923-C045-AAF3-C7A0D9DC07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0F916388-F12D-6545-B7F8-3B513F6CD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27412E10-5D61-7746-9E22-8EDD6BB14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F284820-A330-4345-9A38-49EA0E570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986849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728A05D-2087-6741-9EAA-F0E180317C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A0C2F97B-C3DD-9F48-8403-9897780E25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112F37B1-01D5-324B-BADB-07B0373686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5F56DA2-D69C-3E4D-8869-B53589115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3304BF33-8E7E-5D49-9C31-59AE6AD0B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591CACA-E994-2649-9CF1-33F95CFDF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498913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5AA9A283-9C33-274D-B81A-9A7E92911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35EB42F-C6D4-0246-B79F-47D6C9F2ED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3E35ED5-7A98-F547-B9E2-70B957BA2C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F9184-9A42-3B43-8E49-C8E69485EC6E}" type="datetimeFigureOut">
              <a:rPr kumimoji="1" lang="zh-TW" altLang="en-US" smtClean="0"/>
              <a:t>2020/12/8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68BF7FC-FCFB-3449-8DAA-97B8FC037B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19A950C-2DCC-8B48-ABAA-74B2F7BEB8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D270A6-C3AF-334F-9A05-FE56BC550A0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00708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圖片 7" descr="一張含有 雪, 雨, 覆蓋, 直立的 的圖片&#10;&#10;自動產生的描述">
            <a:extLst>
              <a:ext uri="{FF2B5EF4-FFF2-40B4-BE49-F238E27FC236}">
                <a16:creationId xmlns:a16="http://schemas.microsoft.com/office/drawing/2014/main" id="{8A2D2DE2-4B33-44BF-8E32-2D16C299ABE0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1781" y="2824472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圖片 2" descr="一張含有 麵包, 食物, 坐, 直立的 的圖片&#10;&#10;自動產生的描述">
            <a:extLst>
              <a:ext uri="{FF2B5EF4-FFF2-40B4-BE49-F238E27FC236}">
                <a16:creationId xmlns:a16="http://schemas.microsoft.com/office/drawing/2014/main" id="{B1866A89-9111-44E8-B4DE-F557205B090B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598" y="2826523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4" name="直線接點 23"/>
          <p:cNvCxnSpPr/>
          <p:nvPr/>
        </p:nvCxnSpPr>
        <p:spPr>
          <a:xfrm>
            <a:off x="3490582" y="2140431"/>
            <a:ext cx="468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矩形 25"/>
          <p:cNvSpPr/>
          <p:nvPr/>
        </p:nvSpPr>
        <p:spPr>
          <a:xfrm>
            <a:off x="4608081" y="1772374"/>
            <a:ext cx="24352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oblastoma (Grade 4) 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DE3B9780-E277-419D-A85D-E6228593BD4A}"/>
              </a:ext>
            </a:extLst>
          </p:cNvPr>
          <p:cNvSpPr txBox="1"/>
          <p:nvPr/>
        </p:nvSpPr>
        <p:spPr>
          <a:xfrm>
            <a:off x="3558446" y="2153101"/>
            <a:ext cx="2082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7-specific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6C6DE58D-A721-429A-A951-412C2A3E72A9}"/>
              </a:ext>
            </a:extLst>
          </p:cNvPr>
          <p:cNvSpPr txBox="1"/>
          <p:nvPr/>
        </p:nvSpPr>
        <p:spPr>
          <a:xfrm>
            <a:off x="5511089" y="2153101"/>
            <a:ext cx="30600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F8F5B2B5-1AFB-E64D-9D82-259E3D8BBD08}"/>
              </a:ext>
            </a:extLst>
          </p:cNvPr>
          <p:cNvSpPr txBox="1"/>
          <p:nvPr/>
        </p:nvSpPr>
        <p:spPr>
          <a:xfrm>
            <a:off x="817274" y="6101970"/>
            <a:ext cx="1055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: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negative control antibody staining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the BMP7 antibody specificity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de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oblastoma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.</a:t>
            </a:r>
            <a:r>
              <a: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s are 20 </a:t>
            </a:r>
            <a:r>
              <a:rPr lang="en-US" altLang="zh-TW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TW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 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86760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圖片 32">
            <a:extLst>
              <a:ext uri="{FF2B5EF4-FFF2-40B4-BE49-F238E27FC236}">
                <a16:creationId xmlns:a16="http://schemas.microsoft.com/office/drawing/2014/main" id="{ADE862D9-36CA-FD41-9E4E-3821379DA2A3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489" t="60609" r="662" b="10123"/>
          <a:stretch/>
        </p:blipFill>
        <p:spPr>
          <a:xfrm>
            <a:off x="2486070" y="1116700"/>
            <a:ext cx="3756752" cy="4625405"/>
          </a:xfrm>
          <a:prstGeom prst="rect">
            <a:avLst/>
          </a:prstGeom>
          <a:ln w="12700">
            <a:noFill/>
          </a:ln>
        </p:spPr>
      </p:pic>
      <p:pic>
        <p:nvPicPr>
          <p:cNvPr id="34" name="圖片 33">
            <a:extLst>
              <a:ext uri="{FF2B5EF4-FFF2-40B4-BE49-F238E27FC236}">
                <a16:creationId xmlns:a16="http://schemas.microsoft.com/office/drawing/2014/main" id="{68980C39-A0C4-DB48-A029-C7E6DCEAFF7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932" b="742"/>
          <a:stretch/>
        </p:blipFill>
        <p:spPr>
          <a:xfrm>
            <a:off x="6312291" y="1116700"/>
            <a:ext cx="1878278" cy="391366"/>
          </a:xfrm>
          <a:prstGeom prst="rect">
            <a:avLst/>
          </a:prstGeom>
          <a:ln w="12700">
            <a:noFill/>
          </a:ln>
        </p:spPr>
      </p:pic>
      <p:sp>
        <p:nvSpPr>
          <p:cNvPr id="35" name="文字方塊 34">
            <a:extLst>
              <a:ext uri="{FF2B5EF4-FFF2-40B4-BE49-F238E27FC236}">
                <a16:creationId xmlns:a16="http://schemas.microsoft.com/office/drawing/2014/main" id="{6DFE6271-46AA-2342-8E6A-A420A225DDB1}"/>
              </a:ext>
            </a:extLst>
          </p:cNvPr>
          <p:cNvSpPr txBox="1"/>
          <p:nvPr/>
        </p:nvSpPr>
        <p:spPr>
          <a:xfrm>
            <a:off x="4968234" y="219062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7</a:t>
            </a:r>
            <a:endParaRPr kumimoji="1" lang="zh-TW" altLang="en-US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D6AF9117-6225-6443-B35C-B70209960FAA}"/>
              </a:ext>
            </a:extLst>
          </p:cNvPr>
          <p:cNvSpPr txBox="1"/>
          <p:nvPr/>
        </p:nvSpPr>
        <p:spPr>
          <a:xfrm>
            <a:off x="8260038" y="111670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kumimoji="1" lang="zh-TW" altLang="en-US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255DB3AF-D8BD-E44F-AB25-9F709B46B866}"/>
              </a:ext>
            </a:extLst>
          </p:cNvPr>
          <p:cNvSpPr txBox="1"/>
          <p:nvPr/>
        </p:nvSpPr>
        <p:spPr>
          <a:xfrm>
            <a:off x="2396698" y="58134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2C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BEB80D92-0494-1E43-8701-55878224BFB7}"/>
              </a:ext>
            </a:extLst>
          </p:cNvPr>
          <p:cNvSpPr txBox="1"/>
          <p:nvPr/>
        </p:nvSpPr>
        <p:spPr>
          <a:xfrm>
            <a:off x="3118377" y="6443494"/>
            <a:ext cx="5216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: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s of Western blot in Figures 2A. 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6451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字方塊 22">
            <a:extLst>
              <a:ext uri="{FF2B5EF4-FFF2-40B4-BE49-F238E27FC236}">
                <a16:creationId xmlns:a16="http://schemas.microsoft.com/office/drawing/2014/main" id="{701B2C64-DF2D-C345-B38B-417962FE99E3}"/>
              </a:ext>
            </a:extLst>
          </p:cNvPr>
          <p:cNvSpPr txBox="1"/>
          <p:nvPr/>
        </p:nvSpPr>
        <p:spPr>
          <a:xfrm>
            <a:off x="149257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4A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9FB10A11-A428-AF4E-ACBA-C42E49BA757A}"/>
              </a:ext>
            </a:extLst>
          </p:cNvPr>
          <p:cNvSpPr txBox="1"/>
          <p:nvPr/>
        </p:nvSpPr>
        <p:spPr>
          <a:xfrm>
            <a:off x="2059145" y="2165793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4B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BEB80D92-0494-1E43-8701-55878224BFB7}"/>
              </a:ext>
            </a:extLst>
          </p:cNvPr>
          <p:cNvSpPr txBox="1"/>
          <p:nvPr/>
        </p:nvSpPr>
        <p:spPr>
          <a:xfrm>
            <a:off x="3118377" y="6443494"/>
            <a:ext cx="5063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: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s of Western blot in Figures 4. 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Picture 33" descr="BMP7-P75016">
            <a:extLst>
              <a:ext uri="{FF2B5EF4-FFF2-40B4-BE49-F238E27FC236}">
                <a16:creationId xmlns:a16="http://schemas.microsoft.com/office/drawing/2014/main" id="{2740B6FC-86BA-8A46-890B-129C6ADC254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66" t="34754" r="578" b="38988"/>
          <a:stretch/>
        </p:blipFill>
        <p:spPr bwMode="auto">
          <a:xfrm>
            <a:off x="165856" y="383294"/>
            <a:ext cx="5905041" cy="1655878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34" descr="BMP7-ACTIN003">
            <a:extLst>
              <a:ext uri="{FF2B5EF4-FFF2-40B4-BE49-F238E27FC236}">
                <a16:creationId xmlns:a16="http://schemas.microsoft.com/office/drawing/2014/main" id="{0082358F-A5C1-F346-89CA-D815BEA117D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7" t="44516" r="-190" b="22133"/>
          <a:stretch/>
        </p:blipFill>
        <p:spPr bwMode="auto">
          <a:xfrm>
            <a:off x="6138137" y="383294"/>
            <a:ext cx="5599820" cy="757019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圖片 59">
            <a:extLst>
              <a:ext uri="{FF2B5EF4-FFF2-40B4-BE49-F238E27FC236}">
                <a16:creationId xmlns:a16="http://schemas.microsoft.com/office/drawing/2014/main" id="{15F0EDCE-EC9B-F041-90EB-65F2B5ABF20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52" t="13755" r="315" b="70232"/>
          <a:stretch/>
        </p:blipFill>
        <p:spPr>
          <a:xfrm>
            <a:off x="2949132" y="2165793"/>
            <a:ext cx="6634993" cy="2739582"/>
          </a:xfrm>
          <a:prstGeom prst="rect">
            <a:avLst/>
          </a:prstGeom>
          <a:ln w="28575">
            <a:noFill/>
          </a:ln>
        </p:spPr>
      </p:pic>
      <p:pic>
        <p:nvPicPr>
          <p:cNvPr id="61" name="圖片 60">
            <a:extLst>
              <a:ext uri="{FF2B5EF4-FFF2-40B4-BE49-F238E27FC236}">
                <a16:creationId xmlns:a16="http://schemas.microsoft.com/office/drawing/2014/main" id="{6937FC9E-5949-E442-AACA-74CBE768941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36" t="65776" r="6770" b="23408"/>
          <a:stretch/>
        </p:blipFill>
        <p:spPr>
          <a:xfrm>
            <a:off x="2965731" y="4957281"/>
            <a:ext cx="6344812" cy="1359591"/>
          </a:xfrm>
          <a:prstGeom prst="rect">
            <a:avLst/>
          </a:prstGeom>
          <a:solidFill>
            <a:schemeClr val="tx1"/>
          </a:solidFill>
          <a:ln w="28575">
            <a:noFill/>
          </a:ln>
        </p:spPr>
      </p:pic>
      <p:sp>
        <p:nvSpPr>
          <p:cNvPr id="62" name="文字方塊 61">
            <a:extLst>
              <a:ext uri="{FF2B5EF4-FFF2-40B4-BE49-F238E27FC236}">
                <a16:creationId xmlns:a16="http://schemas.microsoft.com/office/drawing/2014/main" id="{548C3F70-17DF-9846-9F30-5D71DBD965D8}"/>
              </a:ext>
            </a:extLst>
          </p:cNvPr>
          <p:cNvSpPr txBox="1"/>
          <p:nvPr/>
        </p:nvSpPr>
        <p:spPr>
          <a:xfrm>
            <a:off x="2059144" y="497257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4B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字方塊 62">
            <a:extLst>
              <a:ext uri="{FF2B5EF4-FFF2-40B4-BE49-F238E27FC236}">
                <a16:creationId xmlns:a16="http://schemas.microsoft.com/office/drawing/2014/main" id="{F996C096-9C50-BD44-B9DD-63DA500EE52C}"/>
              </a:ext>
            </a:extLst>
          </p:cNvPr>
          <p:cNvSpPr txBox="1"/>
          <p:nvPr/>
        </p:nvSpPr>
        <p:spPr>
          <a:xfrm>
            <a:off x="6138137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4A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2928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5" descr="picture028">
            <a:extLst>
              <a:ext uri="{FF2B5EF4-FFF2-40B4-BE49-F238E27FC236}">
                <a16:creationId xmlns:a16="http://schemas.microsoft.com/office/drawing/2014/main" id="{B2ED4330-9604-324F-863D-0836695B4A72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49" t="23464" r="52582" b="71925"/>
          <a:stretch/>
        </p:blipFill>
        <p:spPr bwMode="auto">
          <a:xfrm>
            <a:off x="3866921" y="594911"/>
            <a:ext cx="4142341" cy="895447"/>
          </a:xfrm>
          <a:prstGeom prst="rect">
            <a:avLst/>
          </a:prstGeom>
          <a:noFill/>
          <a:ln w="285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7" descr="picture030">
            <a:extLst>
              <a:ext uri="{FF2B5EF4-FFF2-40B4-BE49-F238E27FC236}">
                <a16:creationId xmlns:a16="http://schemas.microsoft.com/office/drawing/2014/main" id="{810433F3-9636-7C43-AC35-3A9F99B0C45B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35" t="38642" r="9025" b="47193"/>
          <a:stretch/>
        </p:blipFill>
        <p:spPr bwMode="auto">
          <a:xfrm>
            <a:off x="3866921" y="1575413"/>
            <a:ext cx="5640636" cy="2666082"/>
          </a:xfrm>
          <a:prstGeom prst="rect">
            <a:avLst/>
          </a:prstGeom>
          <a:noFill/>
          <a:ln w="285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8" descr="picture026">
            <a:extLst>
              <a:ext uri="{FF2B5EF4-FFF2-40B4-BE49-F238E27FC236}">
                <a16:creationId xmlns:a16="http://schemas.microsoft.com/office/drawing/2014/main" id="{768F1299-1661-8E48-A56C-27AC17ACC809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3" t="50489" r="49494" b="36423"/>
          <a:stretch/>
        </p:blipFill>
        <p:spPr bwMode="auto">
          <a:xfrm>
            <a:off x="3866921" y="4326550"/>
            <a:ext cx="4043189" cy="1839817"/>
          </a:xfrm>
          <a:prstGeom prst="rect">
            <a:avLst/>
          </a:prstGeom>
          <a:noFill/>
          <a:ln w="285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280F73FF-6F42-6F4D-B748-788668AC5A73}"/>
              </a:ext>
            </a:extLst>
          </p:cNvPr>
          <p:cNvSpPr txBox="1"/>
          <p:nvPr/>
        </p:nvSpPr>
        <p:spPr>
          <a:xfrm>
            <a:off x="3866921" y="183052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5A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F1D959B3-AF7A-2840-92A3-4D387D382155}"/>
              </a:ext>
            </a:extLst>
          </p:cNvPr>
          <p:cNvSpPr txBox="1"/>
          <p:nvPr/>
        </p:nvSpPr>
        <p:spPr>
          <a:xfrm>
            <a:off x="3118377" y="6443494"/>
            <a:ext cx="5229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: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s of Western blot in Figures 5A. 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74858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0" descr="p75003">
            <a:extLst>
              <a:ext uri="{FF2B5EF4-FFF2-40B4-BE49-F238E27FC236}">
                <a16:creationId xmlns:a16="http://schemas.microsoft.com/office/drawing/2014/main" id="{7E370713-747D-174C-87A8-9947C3E4E22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lum contrast="18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86" t="10050" r="123" b="30102"/>
          <a:stretch/>
        </p:blipFill>
        <p:spPr bwMode="auto">
          <a:xfrm>
            <a:off x="3925429" y="1388126"/>
            <a:ext cx="4253430" cy="1619479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3" descr="N-CAD and ACTIN010">
            <a:extLst>
              <a:ext uri="{FF2B5EF4-FFF2-40B4-BE49-F238E27FC236}">
                <a16:creationId xmlns:a16="http://schemas.microsoft.com/office/drawing/2014/main" id="{CAD7F51E-7D05-264E-996E-C34E9CB9228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27" t="54021" r="1284" b="16193"/>
          <a:stretch/>
        </p:blipFill>
        <p:spPr bwMode="auto">
          <a:xfrm>
            <a:off x="3925429" y="4706037"/>
            <a:ext cx="4307595" cy="978667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6" descr="picture020">
            <a:extLst>
              <a:ext uri="{FF2B5EF4-FFF2-40B4-BE49-F238E27FC236}">
                <a16:creationId xmlns:a16="http://schemas.microsoft.com/office/drawing/2014/main" id="{F9EE9F3B-1125-A346-A596-A256C1BB30C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01" t="70566" r="2161" b="19783"/>
          <a:stretch/>
        </p:blipFill>
        <p:spPr bwMode="auto">
          <a:xfrm>
            <a:off x="3925429" y="3140725"/>
            <a:ext cx="6139819" cy="1432192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B9E0147F-DEE2-D34E-B166-069FD3F55FF5}"/>
              </a:ext>
            </a:extLst>
          </p:cNvPr>
          <p:cNvSpPr txBox="1"/>
          <p:nvPr/>
        </p:nvSpPr>
        <p:spPr>
          <a:xfrm>
            <a:off x="3925429" y="1018794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F4BCCEE5-3D5C-BA40-BAF2-AF2510F2B215}"/>
              </a:ext>
            </a:extLst>
          </p:cNvPr>
          <p:cNvSpPr txBox="1"/>
          <p:nvPr/>
        </p:nvSpPr>
        <p:spPr>
          <a:xfrm>
            <a:off x="3118377" y="6443494"/>
            <a:ext cx="5216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: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s of Western blot in Figures 5B. 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38821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文字方塊 55">
            <a:extLst>
              <a:ext uri="{FF2B5EF4-FFF2-40B4-BE49-F238E27FC236}">
                <a16:creationId xmlns:a16="http://schemas.microsoft.com/office/drawing/2014/main" id="{ECCEF30E-940D-564E-83E3-3873DAAE3F76}"/>
              </a:ext>
            </a:extLst>
          </p:cNvPr>
          <p:cNvSpPr txBox="1"/>
          <p:nvPr/>
        </p:nvSpPr>
        <p:spPr>
          <a:xfrm>
            <a:off x="4560982" y="1488299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1" lang="zh-TW" alt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6B</a:t>
            </a:r>
            <a:endParaRPr kumimoji="1" lang="zh-TW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BEB80D92-0494-1E43-8701-55878224BFB7}"/>
              </a:ext>
            </a:extLst>
          </p:cNvPr>
          <p:cNvSpPr txBox="1"/>
          <p:nvPr/>
        </p:nvSpPr>
        <p:spPr>
          <a:xfrm>
            <a:off x="3118377" y="6443494"/>
            <a:ext cx="5216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:</a:t>
            </a:r>
            <a:r>
              <a:rPr kumimoji="1"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s of Western blot in Figures 6B. 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Picture 62" descr="p75NTR024">
            <a:extLst>
              <a:ext uri="{FF2B5EF4-FFF2-40B4-BE49-F238E27FC236}">
                <a16:creationId xmlns:a16="http://schemas.microsoft.com/office/drawing/2014/main" id="{64790846-994B-D248-A306-006FEA6998F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8" t="30489" r="61259" b="19402"/>
          <a:stretch/>
        </p:blipFill>
        <p:spPr bwMode="auto">
          <a:xfrm>
            <a:off x="4560982" y="1899999"/>
            <a:ext cx="1152027" cy="11203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65" descr="ACTIN018">
            <a:extLst>
              <a:ext uri="{FF2B5EF4-FFF2-40B4-BE49-F238E27FC236}">
                <a16:creationId xmlns:a16="http://schemas.microsoft.com/office/drawing/2014/main" id="{92FABD06-F72A-5F4D-93A8-3437228D208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1" t="23768" r="65835" b="25208"/>
          <a:stretch/>
        </p:blipFill>
        <p:spPr bwMode="auto">
          <a:xfrm>
            <a:off x="4560982" y="3062688"/>
            <a:ext cx="2167342" cy="10245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61519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132</Words>
  <Application>Microsoft Macintosh PowerPoint</Application>
  <PresentationFormat>寬螢幕</PresentationFormat>
  <Paragraphs>22</Paragraphs>
  <Slides>6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2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Shun-Fu Chang</dc:creator>
  <cp:lastModifiedBy>Shun-Fu Chang</cp:lastModifiedBy>
  <cp:revision>17</cp:revision>
  <cp:lastPrinted>2020-12-08T08:19:46Z</cp:lastPrinted>
  <dcterms:created xsi:type="dcterms:W3CDTF">2020-05-29T04:34:44Z</dcterms:created>
  <dcterms:modified xsi:type="dcterms:W3CDTF">2020-12-08T09:18:48Z</dcterms:modified>
</cp:coreProperties>
</file>